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75"/>
  </p:normalViewPr>
  <p:slideViewPr>
    <p:cSldViewPr snapToGrid="0">
      <p:cViewPr varScale="1">
        <p:scale>
          <a:sx n="89" d="100"/>
          <a:sy n="89" d="100"/>
        </p:scale>
        <p:origin x="8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omividossa/Documents/Document/KINGSTON/colle&#768;gues/Wetware/cotton%20alanine-melatolin/alanin%20ms/list%20gene%20qRT_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omividossa/Documents/Document/KINGSTON/colle&#768;gues/Wetware/cotton%20alanine-melatolin/alanin%20ms/list%20gene%20qRT_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sz="1600">
                <a:solidFill>
                  <a:schemeClr val="tx1"/>
                </a:solidFill>
              </a:rPr>
              <a:t>A1 vs A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CBF-6D4B-B51C-AD0DF98A9770}"/>
              </c:ext>
            </c:extLst>
          </c:dPt>
          <c:dPt>
            <c:idx val="1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CBF-6D4B-B51C-AD0DF98A9770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CBF-6D4B-B51C-AD0DF98A9770}"/>
              </c:ext>
            </c:extLst>
          </c:dPt>
          <c:dPt>
            <c:idx val="3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CBF-6D4B-B51C-AD0DF98A9770}"/>
              </c:ext>
            </c:extLst>
          </c:dPt>
          <c:dPt>
            <c:idx val="4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CCBF-6D4B-B51C-AD0DF98A9770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CCBF-6D4B-B51C-AD0DF98A9770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CCBF-6D4B-B51C-AD0DF98A9770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CCBF-6D4B-B51C-AD0DF98A9770}"/>
              </c:ext>
            </c:extLst>
          </c:dPt>
          <c:dPt>
            <c:idx val="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CCBF-6D4B-B51C-AD0DF98A9770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CCBF-6D4B-B51C-AD0DF98A9770}"/>
              </c:ext>
            </c:extLst>
          </c:dPt>
          <c:errBars>
            <c:errBarType val="plus"/>
            <c:errValType val="cust"/>
            <c:noEndCap val="0"/>
            <c:plus>
              <c:numRef>
                <c:f>Feuil2!$I$2:$I$11</c:f>
                <c:numCache>
                  <c:formatCode>General</c:formatCode>
                  <c:ptCount val="10"/>
                  <c:pt idx="0">
                    <c:v>-0.75</c:v>
                  </c:pt>
                  <c:pt idx="1">
                    <c:v>-0.63500000000000001</c:v>
                  </c:pt>
                  <c:pt idx="2">
                    <c:v>-0.24166666666666667</c:v>
                  </c:pt>
                  <c:pt idx="3">
                    <c:v>-0.39999999999999997</c:v>
                  </c:pt>
                  <c:pt idx="4">
                    <c:v>-0.20833333333333334</c:v>
                  </c:pt>
                  <c:pt idx="5">
                    <c:v>0.2</c:v>
                  </c:pt>
                  <c:pt idx="6">
                    <c:v>0.391666666666667</c:v>
                  </c:pt>
                  <c:pt idx="7">
                    <c:v>0.39166666666666666</c:v>
                  </c:pt>
                  <c:pt idx="8">
                    <c:v>0.82499999999999996</c:v>
                  </c:pt>
                  <c:pt idx="9">
                    <c:v>0.947058823529411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2!$G$2:$G$11</c:f>
              <c:strCache>
                <c:ptCount val="10"/>
                <c:pt idx="0">
                  <c:v>gene-LOC107885962</c:v>
                </c:pt>
                <c:pt idx="1">
                  <c:v>gene-LOC107936172</c:v>
                </c:pt>
                <c:pt idx="2">
                  <c:v>gene-LOC107941101</c:v>
                </c:pt>
                <c:pt idx="3">
                  <c:v>gene-LOC107895199</c:v>
                </c:pt>
                <c:pt idx="4">
                  <c:v>gene-LOC107929605</c:v>
                </c:pt>
                <c:pt idx="5">
                  <c:v>gene-LOC107889766</c:v>
                </c:pt>
                <c:pt idx="6">
                  <c:v>gene-LOC107890767</c:v>
                </c:pt>
                <c:pt idx="7">
                  <c:v>gene-LOC121220877</c:v>
                </c:pt>
                <c:pt idx="8">
                  <c:v>gene-LOC121224438</c:v>
                </c:pt>
                <c:pt idx="9">
                  <c:v>gene-LOC107900867</c:v>
                </c:pt>
              </c:strCache>
            </c:strRef>
          </c:cat>
          <c:val>
            <c:numRef>
              <c:f>Feuil2!$H$2:$H$11</c:f>
              <c:numCache>
                <c:formatCode>General</c:formatCode>
                <c:ptCount val="10"/>
                <c:pt idx="0">
                  <c:v>-3</c:v>
                </c:pt>
                <c:pt idx="1">
                  <c:v>-4.7</c:v>
                </c:pt>
                <c:pt idx="2">
                  <c:v>-2.9</c:v>
                </c:pt>
                <c:pt idx="3">
                  <c:v>-4.8</c:v>
                </c:pt>
                <c:pt idx="4">
                  <c:v>-2.5</c:v>
                </c:pt>
                <c:pt idx="5">
                  <c:v>3.2</c:v>
                </c:pt>
                <c:pt idx="6">
                  <c:v>2.2999999999999998</c:v>
                </c:pt>
                <c:pt idx="7">
                  <c:v>4.7</c:v>
                </c:pt>
                <c:pt idx="8">
                  <c:v>5.0999999999999996</c:v>
                </c:pt>
                <c:pt idx="9">
                  <c:v>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CCBF-6D4B-B51C-AD0DF98A97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10089184"/>
        <c:axId val="1310090912"/>
      </c:barChart>
      <c:catAx>
        <c:axId val="1310089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10090912"/>
        <c:crosses val="autoZero"/>
        <c:auto val="1"/>
        <c:lblAlgn val="ctr"/>
        <c:lblOffset val="100"/>
        <c:noMultiLvlLbl val="0"/>
      </c:catAx>
      <c:valAx>
        <c:axId val="13100909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100">
                    <a:solidFill>
                      <a:schemeClr val="tx1"/>
                    </a:solidFill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1.0214504596527068E-2"/>
              <c:y val="0.260202429149797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10089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1898950131233596E-2"/>
                  <c:y val="-0.2029115631379410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</c:trendlineLbl>
          </c:trendline>
          <c:xVal>
            <c:numRef>
              <c:f>Feuil2!$H$18:$H$27</c:f>
              <c:numCache>
                <c:formatCode>General</c:formatCode>
                <c:ptCount val="10"/>
                <c:pt idx="0">
                  <c:v>-3</c:v>
                </c:pt>
                <c:pt idx="1">
                  <c:v>-4.7</c:v>
                </c:pt>
                <c:pt idx="2">
                  <c:v>-2.9</c:v>
                </c:pt>
                <c:pt idx="3">
                  <c:v>-4.8</c:v>
                </c:pt>
                <c:pt idx="4">
                  <c:v>-2.5</c:v>
                </c:pt>
                <c:pt idx="5">
                  <c:v>3.2</c:v>
                </c:pt>
                <c:pt idx="6">
                  <c:v>2.2999999999999998</c:v>
                </c:pt>
                <c:pt idx="7">
                  <c:v>4.7</c:v>
                </c:pt>
                <c:pt idx="8">
                  <c:v>5.0999999999999996</c:v>
                </c:pt>
                <c:pt idx="9">
                  <c:v>4.2</c:v>
                </c:pt>
              </c:numCache>
            </c:numRef>
          </c:xVal>
          <c:yVal>
            <c:numRef>
              <c:f>Feuil2!$I$18:$I$27</c:f>
              <c:numCache>
                <c:formatCode>General</c:formatCode>
                <c:ptCount val="10"/>
                <c:pt idx="0">
                  <c:v>-0.75</c:v>
                </c:pt>
                <c:pt idx="1">
                  <c:v>-0.63500000000000001</c:v>
                </c:pt>
                <c:pt idx="2">
                  <c:v>-0.24166666666666667</c:v>
                </c:pt>
                <c:pt idx="3">
                  <c:v>-0.39999999999999997</c:v>
                </c:pt>
                <c:pt idx="4">
                  <c:v>-0.20833333333333334</c:v>
                </c:pt>
                <c:pt idx="5">
                  <c:v>0.2</c:v>
                </c:pt>
                <c:pt idx="6">
                  <c:v>0.391666666666667</c:v>
                </c:pt>
                <c:pt idx="7">
                  <c:v>0.39166666666666666</c:v>
                </c:pt>
                <c:pt idx="8">
                  <c:v>0.82499999999999996</c:v>
                </c:pt>
                <c:pt idx="9">
                  <c:v>0.947058823529411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1BF-8E44-B0E1-74A8E573BD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0338720"/>
        <c:axId val="1315151152"/>
      </c:scatterChart>
      <c:valAx>
        <c:axId val="13103387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100"/>
                  <a:t>qRT-PCR</a:t>
                </a:r>
              </a:p>
            </c:rich>
          </c:tx>
          <c:layout>
            <c:manualLayout>
              <c:xMode val="edge"/>
              <c:yMode val="edge"/>
              <c:x val="0.46441666666666664"/>
              <c:y val="0.901828521434820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15151152"/>
        <c:crosses val="autoZero"/>
        <c:crossBetween val="midCat"/>
      </c:valAx>
      <c:valAx>
        <c:axId val="13151511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100"/>
                  <a:t>RNA-seq</a:t>
                </a:r>
              </a:p>
            </c:rich>
          </c:tx>
          <c:layout>
            <c:manualLayout>
              <c:xMode val="edge"/>
              <c:yMode val="edge"/>
              <c:x val="1.1111111111111112E-2"/>
              <c:y val="0.43984944590259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103387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D621AB-F7DE-C52D-C075-D95328B5BD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65512AC-287F-C73D-EB7B-9F55551014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0E82FB-2869-DCA6-5F81-2544E4D84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9ABA116-9342-8E11-221B-1EA2AE0EA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0581461-33FE-CD9E-249F-B854EECE0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7525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DFA3AA-B94F-D678-4F33-8F3B954A34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5269A85-C86C-9BE6-5328-94A19A61FB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03AD66-3DEC-AE0E-D083-691716C13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AE97C18-403A-4BA0-9165-B8D92A3AC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5E3E211-1A69-8F6D-D8AE-C2358743A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3930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C218E0C-B917-A7EC-C8EB-CEACCC5236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78B4D9B-EF17-9729-94BE-B940708B7C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23B4EA1-C1C4-A42B-8E2B-A77C8F6C3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3B94839-EFBF-B52E-4724-C47505ACF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92C3C41-C12A-49B2-113F-4B316D28C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1543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7DC552-2FF8-9ABC-A7D0-20D77CAED6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007E70-8E32-7328-8BAB-D063D3606D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B4DD983-4300-C947-8CC9-18F75EEC0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CD3B90-0D7C-3E02-A9B7-CF64B93B9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093547-A496-180F-B702-B8A014F07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6283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29E913D-51C6-7CDB-239D-0D7FD1C2E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D0A84B2-694A-7FA6-5B0E-2575F7B60C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4A985FF-BD4A-5807-D17D-17D7C258E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E706B5-894D-85A5-3DF7-7411FBC7D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1515F9C-1E29-7957-0BF0-2E5CBF4A5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9774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369B9C-4051-4ED2-6A20-BC5350C4B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7C3162-E353-196A-CC08-56B1D5B6D8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DA5EE6B-BA16-265C-DA72-B9770C4DA0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FEBE5C3-AD7B-377C-99AA-800DD978B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C3C9FBE-9BA7-4E95-369E-567685D71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BF5EF56-17CE-FDC3-9883-702429BA3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7641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98BE1A-C430-79C1-CABF-CABC69D26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98DEE3E-3D2F-D279-82E3-2E56343E9E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7794121-B134-B43F-902C-90111BD1DE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9FC392D-C3A0-B743-1AC1-F50932243C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D73D553-FA9E-9529-4235-E3DD1AA6DC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D18ADA7-FDBD-61DF-2082-BF844E6DB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E7D5BB2-7971-F791-5C73-28669CB0C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403543E-F962-D9BD-9110-1B1134946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91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88D6D43-F26F-1989-27AC-A66AF3A498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5972675-AB09-67E2-5B77-5E69F2AE7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F23BA24-DCA5-0F8A-70C4-FE7595658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33CF680-154D-8ABB-FE21-A6272293F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3661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0F5F709-D16F-5299-901C-02FF0CE76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E415C3E-036A-7FF1-7404-8DA127BDA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96F4288-9581-0A16-96BA-82F72687E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6049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5B34421-DE84-6705-EAB2-D1003E1EAB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B063686-A200-CEB1-AD4A-4C5FC51236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A0F3A24-E8F7-9893-ACC3-F0676BC799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7F56305-C2B5-5BB0-4C51-6CD797041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CC0E0E9-BBD5-0AE3-9759-C2894DD9E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9CF2AD9-5F86-B54E-BF1B-5DC032F6F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1242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052657-680F-A04C-A529-B6EAFAEC5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2314040-E2C2-B232-47C5-3C5070596D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35FCF09-0744-5CE3-A30D-35D607D352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FB6E23D-72E2-5056-A00B-9FF33B7C1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1A32AE6-A9BD-FB17-7272-871CE64DC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120044E-16E7-5076-B194-17FE09856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7274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18FF7BD-0685-B66F-AD1B-DE8B2024A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9E01496-4BE2-047D-D6F3-A2E5DCD600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67A468-C409-B90B-AAB5-E23747795F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CE0C0-A222-144C-AE82-E76042887DD8}" type="datetimeFigureOut">
              <a:rPr lang="fr-FR" smtClean="0"/>
              <a:t>17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C7F5DF1-E9AC-68E6-5653-20568C216C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FB4C315-C19E-5530-EFF4-61FF06CBDA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8E48D-A0E1-7140-9033-A14017E806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798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91DFC852-183D-7E2E-4D95-62BEF2B59A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6669565"/>
              </p:ext>
            </p:extLst>
          </p:nvPr>
        </p:nvGraphicFramePr>
        <p:xfrm>
          <a:off x="414866" y="305329"/>
          <a:ext cx="6216650" cy="3136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F8F82B86-BD03-1E7A-61AF-1A65192D5A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3858040"/>
              </p:ext>
            </p:extLst>
          </p:nvPr>
        </p:nvGraphicFramePr>
        <p:xfrm>
          <a:off x="7087128" y="642409"/>
          <a:ext cx="4920192" cy="2952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33870131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7</Words>
  <Application>Microsoft Macintosh PowerPoint</Application>
  <PresentationFormat>Grand écran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ffice</dc:creator>
  <cp:lastModifiedBy>office</cp:lastModifiedBy>
  <cp:revision>2</cp:revision>
  <dcterms:created xsi:type="dcterms:W3CDTF">2023-09-14T12:51:47Z</dcterms:created>
  <dcterms:modified xsi:type="dcterms:W3CDTF">2023-09-17T18:38:56Z</dcterms:modified>
</cp:coreProperties>
</file>